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pos="1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1476" y="72"/>
      </p:cViewPr>
      <p:guideLst>
        <p:guide orient="horz" pos="2880"/>
        <p:guide pos="2160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9576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66512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625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79163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93606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77692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5652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71848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44009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6595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30030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DC14EA-5C46-4F41-96DF-D1378857357C}" type="datetimeFigureOut">
              <a:rPr lang="en-IN" smtClean="0"/>
              <a:t>27-04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D3DE1-7C6D-4639-BC12-C751E0D9A9D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30282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jpe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jpeg"/><Relationship Id="rId16" Type="http://schemas.openxmlformats.org/officeDocument/2006/relationships/image" Target="../media/image8.jpeg"/><Relationship Id="rId20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jpe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jpeg"/><Relationship Id="rId19" Type="http://schemas.microsoft.com/office/2007/relationships/hdphoto" Target="../media/hdphoto9.wdp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7.jpeg"/><Relationship Id="rId22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16632" y="217612"/>
            <a:ext cx="6632957" cy="7047338"/>
            <a:chOff x="103753" y="217612"/>
            <a:chExt cx="6632957" cy="7047338"/>
          </a:xfrm>
        </p:grpSpPr>
        <p:grpSp>
          <p:nvGrpSpPr>
            <p:cNvPr id="4" name="Group 3"/>
            <p:cNvGrpSpPr/>
            <p:nvPr/>
          </p:nvGrpSpPr>
          <p:grpSpPr>
            <a:xfrm>
              <a:off x="118352" y="217612"/>
              <a:ext cx="6602767" cy="3116135"/>
              <a:chOff x="118352" y="217612"/>
              <a:chExt cx="6602767" cy="3116135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505732" y="217612"/>
                <a:ext cx="6215387" cy="3116135"/>
                <a:chOff x="111239" y="603170"/>
                <a:chExt cx="6215387" cy="3116135"/>
              </a:xfrm>
            </p:grpSpPr>
            <p:grpSp>
              <p:nvGrpSpPr>
                <p:cNvPr id="7" name="Group 6"/>
                <p:cNvGrpSpPr/>
                <p:nvPr/>
              </p:nvGrpSpPr>
              <p:grpSpPr>
                <a:xfrm>
                  <a:off x="148142" y="924921"/>
                  <a:ext cx="6178484" cy="2794384"/>
                  <a:chOff x="971600" y="510590"/>
                  <a:chExt cx="6178484" cy="2794384"/>
                </a:xfrm>
              </p:grpSpPr>
              <p:pic>
                <p:nvPicPr>
                  <p:cNvPr id="9" name="Picture 3" descr="D:\Running\peanut\Peanut thesis\Peanut imp\Control and drought morphology\DSC06279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sharpenSoften amount="25000"/>
                            </a14:imgEffect>
                            <a14:imgEffect>
                              <a14:brightnessContrast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608" r="18745"/>
                  <a:stretch/>
                </p:blipFill>
                <p:spPr bwMode="auto">
                  <a:xfrm>
                    <a:off x="2397012" y="514973"/>
                    <a:ext cx="1519624" cy="2789096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0" name="Picture 4" descr="D:\Running\peanut\Peanut thesis\Peanut imp\Control and drought morphology\DSC06284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4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sharpenSoften amount="25000"/>
                            </a14:imgEffect>
                            <a14:imgEffect>
                              <a14:brightnessContrast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4752" t="2667" r="23234" b="2151"/>
                  <a:stretch/>
                </p:blipFill>
                <p:spPr bwMode="auto">
                  <a:xfrm>
                    <a:off x="971600" y="510590"/>
                    <a:ext cx="1363306" cy="27900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1" name="Picture 5" descr="D:\Running\peanut\Peanut thesis\Peanut imp\Control and drought morphology\DSC06290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sharpenSoften amount="25000"/>
                            </a14:imgEffect>
                            <a14:imgEffect>
                              <a14:brightnessContrast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7312" t="11613" r="22760" b="3729"/>
                  <a:stretch/>
                </p:blipFill>
                <p:spPr bwMode="auto">
                  <a:xfrm>
                    <a:off x="3974391" y="510590"/>
                    <a:ext cx="1481250" cy="27900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2" name="Picture 7" descr="D:\Running\peanut\Peanut thesis\Peanut imp\Control and drought morphology\DSC06299.JPG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8">
                    <a:extLst>
                      <a:ext uri="{BEBA8EAE-BF5A-486C-A8C5-ECC9F3942E4B}">
                        <a14:imgProps xmlns:a14="http://schemas.microsoft.com/office/drawing/2010/main">
                          <a14:imgLayer r:embed="rId9">
                            <a14:imgEffect>
                              <a14:sharpenSoften amount="25000"/>
                            </a14:imgEffect>
                            <a14:imgEffect>
                              <a14:brightnessContrast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7407" t="3374" r="6994"/>
                  <a:stretch/>
                </p:blipFill>
                <p:spPr bwMode="auto">
                  <a:xfrm>
                    <a:off x="5512948" y="514974"/>
                    <a:ext cx="1637136" cy="27900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sp>
              <p:nvSpPr>
                <p:cNvPr id="8" name="TextBox 7"/>
                <p:cNvSpPr txBox="1"/>
                <p:nvPr/>
              </p:nvSpPr>
              <p:spPr>
                <a:xfrm>
                  <a:off x="111239" y="603170"/>
                  <a:ext cx="617276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    </a:t>
                  </a:r>
                  <a:r>
                    <a:rPr lang="en-US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t</a:t>
                  </a:r>
                  <a:r>
                    <a:rPr lang="en-US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               A1                       A3                        A4     </a:t>
                  </a:r>
                  <a:endParaRPr lang="en-IN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" name="TextBox 5"/>
              <p:cNvSpPr txBox="1"/>
              <p:nvPr/>
            </p:nvSpPr>
            <p:spPr>
              <a:xfrm>
                <a:off x="118352" y="548845"/>
                <a:ext cx="461665" cy="278051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endParaRPr lang="en-IN" b="1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120028" y="5357448"/>
              <a:ext cx="6616682" cy="1907502"/>
              <a:chOff x="120028" y="6271857"/>
              <a:chExt cx="6616682" cy="1907502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529442" y="6271858"/>
                <a:ext cx="6207268" cy="1907501"/>
                <a:chOff x="973334" y="3404732"/>
                <a:chExt cx="6207268" cy="1907501"/>
              </a:xfrm>
            </p:grpSpPr>
            <p:pic>
              <p:nvPicPr>
                <p:cNvPr id="16" name="Picture 8" descr="D:\Running\peanut\Peanut thesis\Peanut imp\Control and drought morphology\DSC06306.JPG"/>
                <p:cNvPicPr>
                  <a:picLocks noChangeAspect="1" noChangeArrowheads="1"/>
                </p:cNvPicPr>
                <p:nvPr/>
              </p:nvPicPr>
              <p:blipFill rotWithShape="1"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sharpenSoften amount="25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971" t="5605" r="25505" b="5363"/>
                <a:stretch/>
              </p:blipFill>
              <p:spPr bwMode="auto">
                <a:xfrm>
                  <a:off x="973334" y="3413929"/>
                  <a:ext cx="1578312" cy="1898101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7" name="Picture 9" descr="D:\Running\peanut\Peanut thesis\Peanut imp\Control and drought morphology\DSC06312.JPG"/>
                <p:cNvPicPr>
                  <a:picLocks noChangeAspect="1" noChangeArrowheads="1"/>
                </p:cNvPicPr>
                <p:nvPr/>
              </p:nvPicPr>
              <p:blipFill rotWithShape="1">
                <a:blip r:embed="rId12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sharpenSoften amount="25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128" t="10686" r="34317" b="5121"/>
                <a:stretch/>
              </p:blipFill>
              <p:spPr bwMode="auto">
                <a:xfrm>
                  <a:off x="2653209" y="3415799"/>
                  <a:ext cx="1368152" cy="189643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8" name="Picture 10" descr="D:\Running\peanut\Peanut thesis\Peanut imp\Control and drought morphology\DSC06320.JPG"/>
                <p:cNvPicPr>
                  <a:picLocks noChangeAspect="1" noChangeArrowheads="1"/>
                </p:cNvPicPr>
                <p:nvPr/>
              </p:nvPicPr>
              <p:blipFill rotWithShape="1">
                <a:blip r:embed="rId14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sharpenSoften amount="25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892" t="3429" r="25080" b="9959"/>
                <a:stretch/>
              </p:blipFill>
              <p:spPr bwMode="auto">
                <a:xfrm>
                  <a:off x="4112686" y="3411172"/>
                  <a:ext cx="1373473" cy="18972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9" name="Picture 11" descr="D:\Running\peanut\Peanut thesis\Peanut imp\Control and drought morphology\DSC06330.JPG"/>
                <p:cNvPicPr>
                  <a:picLocks noChangeAspect="1" noChangeArrowheads="1"/>
                </p:cNvPicPr>
                <p:nvPr/>
              </p:nvPicPr>
              <p:blipFill rotWithShape="1">
                <a:blip r:embed="rId16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sharpenSoften amount="25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156" t="6330" r="23038" b="6572"/>
                <a:stretch/>
              </p:blipFill>
              <p:spPr bwMode="auto">
                <a:xfrm>
                  <a:off x="5588862" y="3404732"/>
                  <a:ext cx="1591740" cy="18972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15" name="TextBox 14"/>
              <p:cNvSpPr txBox="1"/>
              <p:nvPr/>
            </p:nvSpPr>
            <p:spPr>
              <a:xfrm>
                <a:off x="120028" y="6271857"/>
                <a:ext cx="461665" cy="1892997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rought</a:t>
                </a:r>
                <a:endParaRPr lang="en-IN" b="1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103753" y="3416060"/>
              <a:ext cx="6624853" cy="1827797"/>
              <a:chOff x="103753" y="3450566"/>
              <a:chExt cx="6624853" cy="1827797"/>
            </a:xfrm>
          </p:grpSpPr>
          <p:grpSp>
            <p:nvGrpSpPr>
              <p:cNvPr id="21" name="Group 20"/>
              <p:cNvGrpSpPr/>
              <p:nvPr/>
            </p:nvGrpSpPr>
            <p:grpSpPr>
              <a:xfrm>
                <a:off x="530678" y="3471772"/>
                <a:ext cx="6197928" cy="1800001"/>
                <a:chOff x="530678" y="3471772"/>
                <a:chExt cx="6197928" cy="1800001"/>
              </a:xfrm>
            </p:grpSpPr>
            <p:pic>
              <p:nvPicPr>
                <p:cNvPr id="23" name="Picture 2" descr="H:\Ground nut\DSC_0146.JPG"/>
                <p:cNvPicPr>
                  <a:picLocks noChangeAspect="1" noChangeArrowheads="1"/>
                </p:cNvPicPr>
                <p:nvPr/>
              </p:nvPicPr>
              <p:blipFill rotWithShape="1">
                <a:blip r:embed="rId18" cstate="print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321" r="36742"/>
                <a:stretch/>
              </p:blipFill>
              <p:spPr bwMode="auto">
                <a:xfrm>
                  <a:off x="530678" y="3471772"/>
                  <a:ext cx="1420393" cy="180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4" name="Picture 3" descr="H:\Ground nut\DSC_0155.JPG"/>
                <p:cNvPicPr>
                  <a:picLocks noChangeAspect="1" noChangeArrowheads="1"/>
                </p:cNvPicPr>
                <p:nvPr/>
              </p:nvPicPr>
              <p:blipFill rotWithShape="1">
                <a:blip r:embed="rId20" cstate="print">
                  <a:extLst>
                    <a:ext uri="{BEBA8EAE-BF5A-486C-A8C5-ECC9F3942E4B}">
                      <a14:imgProps xmlns:a14="http://schemas.microsoft.com/office/drawing/2010/main">
                        <a14:imgLayer r:embed="rId21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400" r="20601"/>
                <a:stretch/>
              </p:blipFill>
              <p:spPr bwMode="auto">
                <a:xfrm>
                  <a:off x="2046523" y="3471772"/>
                  <a:ext cx="1343982" cy="180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5" name="Picture 4" descr="H:\Ground nut\DSC_0166.JPG"/>
                <p:cNvPicPr>
                  <a:picLocks noChangeAspect="1" noChangeArrowheads="1"/>
                </p:cNvPicPr>
                <p:nvPr/>
              </p:nvPicPr>
              <p:blipFill rotWithShape="1">
                <a:blip r:embed="rId22" cstate="print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200" r="30701" b="3743"/>
                <a:stretch/>
              </p:blipFill>
              <p:spPr bwMode="auto">
                <a:xfrm>
                  <a:off x="3524409" y="3471773"/>
                  <a:ext cx="1466062" cy="180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6" name="Picture 5" descr="H:\Ground nut\DSC_0172.JPG"/>
                <p:cNvPicPr>
                  <a:picLocks noChangeAspect="1" noChangeArrowheads="1"/>
                </p:cNvPicPr>
                <p:nvPr/>
              </p:nvPicPr>
              <p:blipFill rotWithShape="1">
                <a:blip r:embed="rId24" cstate="print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09" t="30649" r="3291" b="16524"/>
                <a:stretch/>
              </p:blipFill>
              <p:spPr bwMode="auto">
                <a:xfrm>
                  <a:off x="5093990" y="3471772"/>
                  <a:ext cx="1634616" cy="18000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22" name="TextBox 21"/>
              <p:cNvSpPr txBox="1"/>
              <p:nvPr/>
            </p:nvSpPr>
            <p:spPr>
              <a:xfrm>
                <a:off x="103753" y="3450566"/>
                <a:ext cx="461665" cy="1827797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b="1" dirty="0" smtClean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linity</a:t>
                </a:r>
                <a:endParaRPr lang="en-IN" b="1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3" name="TextBox 2"/>
          <p:cNvSpPr txBox="1"/>
          <p:nvPr/>
        </p:nvSpPr>
        <p:spPr>
          <a:xfrm>
            <a:off x="421843" y="7452320"/>
            <a:ext cx="63449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IN" b="1" smtClean="0">
                <a:solidFill>
                  <a:srgbClr val="C00000"/>
                </a:solidFill>
                <a:latin typeface="Times New Roman" pitchFamily="18" charset="0"/>
                <a:cs typeface="Times New Roman" pitchFamily="18" charset="0"/>
              </a:rPr>
              <a:t>S8: </a:t>
            </a:r>
            <a:r>
              <a:rPr lang="en-IN" b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Morphological differences in </a:t>
            </a:r>
            <a:r>
              <a:rPr lang="en-IN" b="1" dirty="0" err="1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Wt</a:t>
            </a:r>
            <a:r>
              <a:rPr lang="en-IN" b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 and transgenic lines at control </a:t>
            </a:r>
            <a:r>
              <a:rPr lang="en-IN" b="1" dirty="0" smtClean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and stress treatment </a:t>
            </a:r>
            <a:r>
              <a:rPr lang="en-IN" b="1" dirty="0">
                <a:solidFill>
                  <a:srgbClr val="0000CC"/>
                </a:solidFill>
                <a:latin typeface="Times New Roman" pitchFamily="18" charset="0"/>
                <a:cs typeface="Times New Roman" pitchFamily="18" charset="0"/>
              </a:rPr>
              <a:t>conditions.</a:t>
            </a:r>
            <a:endParaRPr lang="en-IN" dirty="0">
              <a:solidFill>
                <a:srgbClr val="0000CC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41832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5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11</cp:revision>
  <dcterms:created xsi:type="dcterms:W3CDTF">2014-06-05T15:56:59Z</dcterms:created>
  <dcterms:modified xsi:type="dcterms:W3CDTF">2015-04-27T06:21:05Z</dcterms:modified>
</cp:coreProperties>
</file>